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9" autoAdjust="0"/>
    <p:restoredTop sz="94660"/>
  </p:normalViewPr>
  <p:slideViewPr>
    <p:cSldViewPr snapToGrid="0">
      <p:cViewPr varScale="1">
        <p:scale>
          <a:sx n="96" d="100"/>
          <a:sy n="96" d="100"/>
        </p:scale>
        <p:origin x="72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anja\Documents\Data_P_Z\Publikacije\CLANKI\Preparation_AAB\Antibiotic%20Resistance\Manuscript_Tables\Figure%20S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anja\Documents\Data_P_Z\Publikacije\CLANKI\Preparation_AAB\Antibiotic%20Resistance\Manuscript_Tables\Figure%20S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E$4</c:f>
              <c:strCache>
                <c:ptCount val="1"/>
                <c:pt idx="0">
                  <c:v>Resistant strains of Acetobacter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D$5:$D$10</c:f>
              <c:strCache>
                <c:ptCount val="6"/>
                <c:pt idx="0">
                  <c:v>GMN</c:v>
                </c:pt>
                <c:pt idx="1">
                  <c:v>AMP</c:v>
                </c:pt>
                <c:pt idx="2">
                  <c:v>CHL</c:v>
                </c:pt>
                <c:pt idx="3">
                  <c:v>CIP</c:v>
                </c:pt>
                <c:pt idx="4">
                  <c:v>ERY</c:v>
                </c:pt>
                <c:pt idx="5">
                  <c:v>TMP</c:v>
                </c:pt>
              </c:strCache>
            </c:strRef>
          </c:cat>
          <c:val>
            <c:numRef>
              <c:f>Sheet1!$E$5:$E$10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69.2</c:v>
                </c:pt>
                <c:pt idx="3">
                  <c:v>84.6</c:v>
                </c:pt>
                <c:pt idx="4">
                  <c:v>46.1</c:v>
                </c:pt>
                <c:pt idx="5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E02-4B54-8809-1B31DC3396E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52873791"/>
        <c:axId val="2052874623"/>
      </c:barChart>
      <c:catAx>
        <c:axId val="205287379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>
                    <a:latin typeface="Palatino Linotype" panose="02040502050505030304" pitchFamily="18" charset="0"/>
                  </a:rPr>
                  <a:t>Antibiotic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052874623"/>
        <c:crosses val="autoZero"/>
        <c:auto val="1"/>
        <c:lblAlgn val="ctr"/>
        <c:lblOffset val="100"/>
        <c:noMultiLvlLbl val="0"/>
      </c:catAx>
      <c:valAx>
        <c:axId val="2052874623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Arial" panose="020B0604020202020204" pitchFamily="34" charset="0"/>
                  </a:defRPr>
                </a:pPr>
                <a:r>
                  <a:rPr lang="sl-SI" sz="1000">
                    <a:latin typeface="Palatino Linotype" panose="02040502050505030304" pitchFamily="18" charset="0"/>
                  </a:rPr>
                  <a:t>Resistant</a:t>
                </a:r>
                <a:r>
                  <a:rPr lang="sl-SI" sz="1000" baseline="0">
                    <a:latin typeface="Palatino Linotype" panose="02040502050505030304" pitchFamily="18" charset="0"/>
                  </a:rPr>
                  <a:t> strains (%)</a:t>
                </a:r>
                <a:endParaRPr lang="en-GB" sz="1000">
                  <a:latin typeface="Palatino Linotype" panose="0204050205050503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#,##0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052873791"/>
        <c:crosses val="autoZero"/>
        <c:crossBetween val="between"/>
        <c:majorUnit val="2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2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D$24:$D$29</c:f>
              <c:strCache>
                <c:ptCount val="6"/>
                <c:pt idx="0">
                  <c:v>GMN</c:v>
                </c:pt>
                <c:pt idx="1">
                  <c:v>AMP</c:v>
                </c:pt>
                <c:pt idx="2">
                  <c:v>CHL</c:v>
                </c:pt>
                <c:pt idx="3">
                  <c:v>CIP</c:v>
                </c:pt>
                <c:pt idx="4">
                  <c:v>ERY</c:v>
                </c:pt>
                <c:pt idx="5">
                  <c:v>TMP</c:v>
                </c:pt>
              </c:strCache>
            </c:strRef>
          </c:cat>
          <c:val>
            <c:numRef>
              <c:f>Sheet1!$E$24:$E$29</c:f>
              <c:numCache>
                <c:formatCode>General</c:formatCode>
                <c:ptCount val="6"/>
                <c:pt idx="0">
                  <c:v>0</c:v>
                </c:pt>
                <c:pt idx="1">
                  <c:v>3.8</c:v>
                </c:pt>
                <c:pt idx="2">
                  <c:v>15.4</c:v>
                </c:pt>
                <c:pt idx="3">
                  <c:v>42.3</c:v>
                </c:pt>
                <c:pt idx="4">
                  <c:v>84.6</c:v>
                </c:pt>
                <c:pt idx="5">
                  <c:v>96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4CE-4B66-A6DF-0150A2B2AB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58494096"/>
        <c:axId val="1058494512"/>
      </c:barChart>
      <c:catAx>
        <c:axId val="10584940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sl-SI">
                    <a:latin typeface="Palatino Linotype" panose="02040502050505030304" pitchFamily="18" charset="0"/>
                  </a:rPr>
                  <a:t>Antibiotic</a:t>
                </a:r>
                <a:endParaRPr lang="en-GB">
                  <a:latin typeface="Palatino Linotype" panose="0204050205050503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1058494512"/>
        <c:crosses val="autoZero"/>
        <c:auto val="1"/>
        <c:lblAlgn val="ctr"/>
        <c:lblOffset val="100"/>
        <c:noMultiLvlLbl val="0"/>
      </c:catAx>
      <c:valAx>
        <c:axId val="1058494512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sl-SI">
                    <a:latin typeface="Palatino Linotype" panose="02040502050505030304" pitchFamily="18" charset="0"/>
                  </a:rPr>
                  <a:t>Resistant</a:t>
                </a:r>
                <a:r>
                  <a:rPr lang="sl-SI" baseline="0">
                    <a:latin typeface="Palatino Linotype" panose="02040502050505030304" pitchFamily="18" charset="0"/>
                  </a:rPr>
                  <a:t> strains (%)</a:t>
                </a:r>
                <a:endParaRPr lang="en-GB">
                  <a:latin typeface="Palatino Linotype" panose="0204050205050503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58494096"/>
        <c:crosses val="autoZero"/>
        <c:crossBetween val="between"/>
        <c:majorUnit val="2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1CCB0C-115C-4A21-9E58-8CB6A4758F4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9DB7531-AAEC-4B81-9924-41FC33E95E0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CB2695-9E71-4A9C-B870-C8B16CECA0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40410-1E5E-43BC-B2C4-99D39E48D6F5}" type="datetimeFigureOut">
              <a:rPr lang="en-GB" smtClean="0"/>
              <a:t>27. 12. 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9C585C-2391-44A4-B6CD-5E457990A6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6B8F9C-33B6-40AF-BB7A-68DE38462C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C53C9-46E6-4A1A-93D7-0F39B4BEC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84557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91A360-9CC0-4573-8E10-CB56BDCC15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D30C210-F5A0-430F-A7F9-39FF80510E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ABEECC-5CBC-42FB-BF84-B552F5C7D7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40410-1E5E-43BC-B2C4-99D39E48D6F5}" type="datetimeFigureOut">
              <a:rPr lang="en-GB" smtClean="0"/>
              <a:t>27. 12. 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24220D-4C28-41A7-9659-E45CADB5E3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75963F-6E31-4413-B101-BA1143F394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C53C9-46E6-4A1A-93D7-0F39B4BEC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31995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BAE8551-2AD8-446C-9563-677B56F8C52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04F8F8E-AFB4-46BE-B508-7DD45741712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1F8965-5E76-4DD0-9F87-5EF1C9663F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40410-1E5E-43BC-B2C4-99D39E48D6F5}" type="datetimeFigureOut">
              <a:rPr lang="en-GB" smtClean="0"/>
              <a:t>27. 12. 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2BA41F-8118-4E2D-8767-1FDA5D536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E6DDE4-6DA5-49B0-ABF7-4D6EE0049D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C53C9-46E6-4A1A-93D7-0F39B4BEC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75184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F3D82-487D-424B-8ED3-C91D4DB59C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0EB6198-860A-43D8-B644-93D94E26565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5CC224-93B3-4848-B00E-EB5268C8A7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40410-1E5E-43BC-B2C4-99D39E48D6F5}" type="datetimeFigureOut">
              <a:rPr lang="en-GB" smtClean="0"/>
              <a:t>27. 12. 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1DDE17-A120-4945-AB14-295D966F0F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D385EE-FA82-4BD2-B761-3074B8D4EA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C53C9-46E6-4A1A-93D7-0F39B4BEC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94737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79E125-16F2-4065-879B-201720307C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05B8C15-AF05-40E3-9F53-05E0EE9B73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6D2CE4-6BE0-4ECB-AB29-6A5497FFFD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40410-1E5E-43BC-B2C4-99D39E48D6F5}" type="datetimeFigureOut">
              <a:rPr lang="en-GB" smtClean="0"/>
              <a:t>27. 12. 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27FA7D-A60A-4A31-A537-6490A3BF5D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391B4A-25BD-43C5-9F65-F2B53FAB25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C53C9-46E6-4A1A-93D7-0F39B4BEC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44177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A341CD-0A97-4B8C-B9F1-72FAF2FD3D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8360926-E889-47D3-B942-350D881A8DE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D20F92C-F730-40DA-8766-9A3A741017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82770D-7A87-45B4-8CE3-CF37CD3D40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40410-1E5E-43BC-B2C4-99D39E48D6F5}" type="datetimeFigureOut">
              <a:rPr lang="en-GB" smtClean="0"/>
              <a:t>27. 12. 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B9936D0-5245-45A8-B136-81D2F99D8A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4301D35-DE1B-4CCE-8DDF-E9D1629B88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C53C9-46E6-4A1A-93D7-0F39B4BEC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5808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AE6F10-DAF9-4AD6-B080-71CED85D61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643096-2498-499D-9387-69D4F410F8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197052-4E1F-481C-A90B-9973F938DA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7297519-E7CA-4097-BF62-8FC862F92CF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67AA976-0716-4AD3-B841-23AEDD9664A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F97683F-609B-4C1B-80AB-B72AB32669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40410-1E5E-43BC-B2C4-99D39E48D6F5}" type="datetimeFigureOut">
              <a:rPr lang="en-GB" smtClean="0"/>
              <a:t>27. 12. 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7F7120B-103B-4602-83BF-AD8DD18EC2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A76A5B4-DA8F-4445-A139-58FD73C325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C53C9-46E6-4A1A-93D7-0F39B4BEC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1511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ADFB2B-69A0-420A-97F6-43EADE77FA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69DF5D5-E929-4E6F-A73E-CC7AB67E6C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40410-1E5E-43BC-B2C4-99D39E48D6F5}" type="datetimeFigureOut">
              <a:rPr lang="en-GB" smtClean="0"/>
              <a:t>27. 12. 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B04760D-2750-43CE-BDDF-6209365014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426BD12-8895-4448-88EF-1213734D2F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C53C9-46E6-4A1A-93D7-0F39B4BEC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41549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5A9536F-93C3-4C67-8657-0E43885E73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40410-1E5E-43BC-B2C4-99D39E48D6F5}" type="datetimeFigureOut">
              <a:rPr lang="en-GB" smtClean="0"/>
              <a:t>27. 12. 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D80A6C2-49E3-412D-BF35-74F1BD0EAC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FEADAE5-AAF4-490D-8129-C7E90FD1E3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C53C9-46E6-4A1A-93D7-0F39B4BEC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26284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30D474-DB3D-4EC9-8355-355889A5A7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4D6240-0D45-48C1-9C5C-1C00BF03116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E69774E-0FA6-4515-81FB-FDC024AE933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693FB5-763D-41B4-BABB-24D0C9F9F5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40410-1E5E-43BC-B2C4-99D39E48D6F5}" type="datetimeFigureOut">
              <a:rPr lang="en-GB" smtClean="0"/>
              <a:t>27. 12. 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44379F-C638-40BD-B53A-7B89F677A6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79F2DF-9CB8-4557-8E2D-29BC423548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C53C9-46E6-4A1A-93D7-0F39B4BEC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32136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191486-6366-43FF-8998-CB948B3F49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E0819A9-4867-44E2-B42A-231F0841AE6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4CC8AFE-5C08-4097-B662-CB33B5A2B6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483C21-966F-4D45-98E8-52C8C97A3A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40410-1E5E-43BC-B2C4-99D39E48D6F5}" type="datetimeFigureOut">
              <a:rPr lang="en-GB" smtClean="0"/>
              <a:t>27. 12. 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B26FED0-FF09-4ACE-A02F-E44AF1F03D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211EA9-B404-4719-B728-234DA62082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C53C9-46E6-4A1A-93D7-0F39B4BEC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62531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BA60245-1C92-42D1-9217-5FB539604F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9D8860-9860-4CCF-B586-732CD1E950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5027D8-71ED-4896-865E-F984542475F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A40410-1E5E-43BC-B2C4-99D39E48D6F5}" type="datetimeFigureOut">
              <a:rPr lang="en-GB" smtClean="0"/>
              <a:t>27. 12. 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5AE8CD-A75C-4A6F-8DC1-8C76FB5EC89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64A830-701E-4EA6-A0BE-006F52B317C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2C53C9-46E6-4A1A-93D7-0F39B4BEC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3414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87F8C310-2879-463B-A1D8-B7AFFC1744A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90206406"/>
              </p:ext>
            </p:extLst>
          </p:nvPr>
        </p:nvGraphicFramePr>
        <p:xfrm>
          <a:off x="880658" y="1443785"/>
          <a:ext cx="4562621" cy="29073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17D82E01-03E6-449C-8986-0146399B34EF}"/>
              </a:ext>
            </a:extLst>
          </p:cNvPr>
          <p:cNvSpPr txBox="1"/>
          <p:nvPr/>
        </p:nvSpPr>
        <p:spPr>
          <a:xfrm>
            <a:off x="811033" y="302150"/>
            <a:ext cx="1006635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sl-SI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</a:t>
            </a: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. </a:t>
            </a:r>
            <a:r>
              <a:rPr lang="sl-SI" sz="14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trains</a:t>
            </a:r>
            <a:r>
              <a:rPr lang="sl-SI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sl-SI" sz="14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f</a:t>
            </a:r>
            <a:r>
              <a:rPr lang="sl-SI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sl-SI" sz="1400" i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cetobacter</a:t>
            </a:r>
            <a:r>
              <a:rPr lang="sl-SI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sl-SI" sz="14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pecies</a:t>
            </a:r>
            <a:r>
              <a:rPr lang="sl-SI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A) and </a:t>
            </a:r>
            <a:r>
              <a:rPr lang="sl-SI" sz="1400" i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Komagataeibacter</a:t>
            </a:r>
            <a:r>
              <a:rPr lang="sl-SI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sl-SI" sz="14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pecies</a:t>
            </a:r>
            <a:r>
              <a:rPr lang="sl-SI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B) </a:t>
            </a:r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esistant to 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gentamicin (GMN)</a:t>
            </a:r>
            <a:r>
              <a:rPr lang="sl-SI" sz="140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</a:t>
            </a:r>
            <a:r>
              <a:rPr lang="en-US" sz="140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mpicillin </a:t>
            </a:r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AMP), chloramphenicol (CHL), ciprofloxacin (CIP), erythromycin (ERY), and trimethoprim (TMP).</a:t>
            </a:r>
            <a:endParaRPr lang="en-GB" sz="14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AA0A3E5-CBC8-418C-9DBB-4987D471FBD6}"/>
              </a:ext>
            </a:extLst>
          </p:cNvPr>
          <p:cNvSpPr txBox="1"/>
          <p:nvPr/>
        </p:nvSpPr>
        <p:spPr>
          <a:xfrm>
            <a:off x="993913" y="1105231"/>
            <a:ext cx="4452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l-SI" sz="1600" dirty="0"/>
              <a:t>A</a:t>
            </a:r>
            <a:endParaRPr lang="en-GB" sz="16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C6A7AC1-4738-4B36-BC14-92BE29385D49}"/>
              </a:ext>
            </a:extLst>
          </p:cNvPr>
          <p:cNvSpPr txBox="1"/>
          <p:nvPr/>
        </p:nvSpPr>
        <p:spPr>
          <a:xfrm>
            <a:off x="6163586" y="1105231"/>
            <a:ext cx="4452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l-SI" sz="1600" dirty="0"/>
              <a:t>B</a:t>
            </a:r>
            <a:endParaRPr lang="en-GB" sz="1600" dirty="0"/>
          </a:p>
        </p:txBody>
      </p:sp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5A4BA76C-264F-447B-BBA7-63E1363FF17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78371277"/>
              </p:ext>
            </p:extLst>
          </p:nvPr>
        </p:nvGraphicFramePr>
        <p:xfrm>
          <a:off x="6028415" y="1443785"/>
          <a:ext cx="4572000" cy="29073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7059836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55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ja Trček</dc:creator>
  <cp:lastModifiedBy>Janja Trček</cp:lastModifiedBy>
  <cp:revision>3</cp:revision>
  <dcterms:created xsi:type="dcterms:W3CDTF">2021-12-26T16:36:24Z</dcterms:created>
  <dcterms:modified xsi:type="dcterms:W3CDTF">2021-12-27T01:37:48Z</dcterms:modified>
</cp:coreProperties>
</file>